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3" d="100"/>
          <a:sy n="83" d="100"/>
        </p:scale>
        <p:origin x="614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Han, Hyeondae" userId="67432371-20d1-4115-886e-4ef881c3fd68" providerId="ADAL" clId="{E3077698-65F1-49EA-9BE1-98CCDA0BF02F}"/>
    <pc:docChg chg="modSld">
      <pc:chgData name="Han, Hyeondae" userId="67432371-20d1-4115-886e-4ef881c3fd68" providerId="ADAL" clId="{E3077698-65F1-49EA-9BE1-98CCDA0BF02F}" dt="2024-03-25T12:51:59.085" v="0" actId="255"/>
      <pc:docMkLst>
        <pc:docMk/>
      </pc:docMkLst>
      <pc:sldChg chg="modSp mod">
        <pc:chgData name="Han, Hyeondae" userId="67432371-20d1-4115-886e-4ef881c3fd68" providerId="ADAL" clId="{E3077698-65F1-49EA-9BE1-98CCDA0BF02F}" dt="2024-03-25T12:51:59.085" v="0" actId="255"/>
        <pc:sldMkLst>
          <pc:docMk/>
          <pc:sldMk cId="1959538778" sldId="256"/>
        </pc:sldMkLst>
        <pc:spChg chg="mod">
          <ac:chgData name="Han, Hyeondae" userId="67432371-20d1-4115-886e-4ef881c3fd68" providerId="ADAL" clId="{E3077698-65F1-49EA-9BE1-98CCDA0BF02F}" dt="2024-03-25T12:51:59.085" v="0" actId="255"/>
          <ac:spMkLst>
            <pc:docMk/>
            <pc:sldMk cId="1959538778" sldId="256"/>
            <ac:spMk id="3" creationId="{B423628A-4116-6B6E-9F23-9E201D3D379E}"/>
          </ac:spMkLst>
        </pc:s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&#53685;&#54633;%20&#47928;&#49436;1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FaFB1_hap1</c:v>
                </c:pt>
              </c:strCache>
            </c:strRef>
          </c:tx>
          <c:spPr>
            <a:solidFill>
              <a:srgbClr val="00B0F0"/>
            </a:solidFill>
            <a:ln>
              <a:noFill/>
            </a:ln>
            <a:effectLst/>
          </c:spPr>
          <c:invertIfNegative val="0"/>
          <c:cat>
            <c:strRef>
              <c:f>Sheet1!$A$2:$A$29</c:f>
              <c:strCache>
                <c:ptCount val="28"/>
                <c:pt idx="0">
                  <c:v>1A</c:v>
                </c:pt>
                <c:pt idx="1">
                  <c:v>1B</c:v>
                </c:pt>
                <c:pt idx="2">
                  <c:v>1C</c:v>
                </c:pt>
                <c:pt idx="3">
                  <c:v>1D</c:v>
                </c:pt>
                <c:pt idx="4">
                  <c:v>2A</c:v>
                </c:pt>
                <c:pt idx="5">
                  <c:v>2B</c:v>
                </c:pt>
                <c:pt idx="6">
                  <c:v>2C</c:v>
                </c:pt>
                <c:pt idx="7">
                  <c:v>2D</c:v>
                </c:pt>
                <c:pt idx="8">
                  <c:v>3A</c:v>
                </c:pt>
                <c:pt idx="9">
                  <c:v>3B</c:v>
                </c:pt>
                <c:pt idx="10">
                  <c:v>3C</c:v>
                </c:pt>
                <c:pt idx="11">
                  <c:v>3D</c:v>
                </c:pt>
                <c:pt idx="12">
                  <c:v>4A</c:v>
                </c:pt>
                <c:pt idx="13">
                  <c:v>4B</c:v>
                </c:pt>
                <c:pt idx="14">
                  <c:v>4C</c:v>
                </c:pt>
                <c:pt idx="15">
                  <c:v>4D</c:v>
                </c:pt>
                <c:pt idx="16">
                  <c:v>5A</c:v>
                </c:pt>
                <c:pt idx="17">
                  <c:v>5B</c:v>
                </c:pt>
                <c:pt idx="18">
                  <c:v>5C</c:v>
                </c:pt>
                <c:pt idx="19">
                  <c:v>5D</c:v>
                </c:pt>
                <c:pt idx="20">
                  <c:v>6A</c:v>
                </c:pt>
                <c:pt idx="21">
                  <c:v>6B</c:v>
                </c:pt>
                <c:pt idx="22">
                  <c:v>6C</c:v>
                </c:pt>
                <c:pt idx="23">
                  <c:v>6D</c:v>
                </c:pt>
                <c:pt idx="24">
                  <c:v>7A</c:v>
                </c:pt>
                <c:pt idx="25">
                  <c:v>7B</c:v>
                </c:pt>
                <c:pt idx="26">
                  <c:v>7C</c:v>
                </c:pt>
                <c:pt idx="27">
                  <c:v>7D</c:v>
                </c:pt>
              </c:strCache>
            </c:strRef>
          </c:cat>
          <c:val>
            <c:numRef>
              <c:f>Sheet1!$B$2:$B$29</c:f>
              <c:numCache>
                <c:formatCode>General</c:formatCode>
                <c:ptCount val="28"/>
                <c:pt idx="0">
                  <c:v>23567252</c:v>
                </c:pt>
                <c:pt idx="1">
                  <c:v>26785871</c:v>
                </c:pt>
                <c:pt idx="2">
                  <c:v>26527737</c:v>
                </c:pt>
                <c:pt idx="3">
                  <c:v>26433688</c:v>
                </c:pt>
                <c:pt idx="4">
                  <c:v>27144803</c:v>
                </c:pt>
                <c:pt idx="5">
                  <c:v>27757423</c:v>
                </c:pt>
                <c:pt idx="6">
                  <c:v>26941598</c:v>
                </c:pt>
                <c:pt idx="7">
                  <c:v>28016282</c:v>
                </c:pt>
                <c:pt idx="8">
                  <c:v>31194221</c:v>
                </c:pt>
                <c:pt idx="9">
                  <c:v>30755514</c:v>
                </c:pt>
                <c:pt idx="10">
                  <c:v>31090695</c:v>
                </c:pt>
                <c:pt idx="11">
                  <c:v>30266732</c:v>
                </c:pt>
                <c:pt idx="12">
                  <c:v>27193533</c:v>
                </c:pt>
                <c:pt idx="13">
                  <c:v>30511584</c:v>
                </c:pt>
                <c:pt idx="14">
                  <c:v>26858130</c:v>
                </c:pt>
                <c:pt idx="15">
                  <c:v>25535583</c:v>
                </c:pt>
                <c:pt idx="16">
                  <c:v>26252604</c:v>
                </c:pt>
                <c:pt idx="17">
                  <c:v>28272564</c:v>
                </c:pt>
                <c:pt idx="18">
                  <c:v>26214383</c:v>
                </c:pt>
                <c:pt idx="19">
                  <c:v>26255631</c:v>
                </c:pt>
                <c:pt idx="20">
                  <c:v>34110432</c:v>
                </c:pt>
                <c:pt idx="21">
                  <c:v>36373116</c:v>
                </c:pt>
                <c:pt idx="22">
                  <c:v>34799956</c:v>
                </c:pt>
                <c:pt idx="23">
                  <c:v>33615062</c:v>
                </c:pt>
                <c:pt idx="24">
                  <c:v>22721161</c:v>
                </c:pt>
                <c:pt idx="25">
                  <c:v>24003555</c:v>
                </c:pt>
                <c:pt idx="26">
                  <c:v>23810172</c:v>
                </c:pt>
                <c:pt idx="27">
                  <c:v>2191918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6DE-4AEF-80A5-DBBE5F280033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FaFB1_hap2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1!$A$2:$A$29</c:f>
              <c:strCache>
                <c:ptCount val="28"/>
                <c:pt idx="0">
                  <c:v>1A</c:v>
                </c:pt>
                <c:pt idx="1">
                  <c:v>1B</c:v>
                </c:pt>
                <c:pt idx="2">
                  <c:v>1C</c:v>
                </c:pt>
                <c:pt idx="3">
                  <c:v>1D</c:v>
                </c:pt>
                <c:pt idx="4">
                  <c:v>2A</c:v>
                </c:pt>
                <c:pt idx="5">
                  <c:v>2B</c:v>
                </c:pt>
                <c:pt idx="6">
                  <c:v>2C</c:v>
                </c:pt>
                <c:pt idx="7">
                  <c:v>2D</c:v>
                </c:pt>
                <c:pt idx="8">
                  <c:v>3A</c:v>
                </c:pt>
                <c:pt idx="9">
                  <c:v>3B</c:v>
                </c:pt>
                <c:pt idx="10">
                  <c:v>3C</c:v>
                </c:pt>
                <c:pt idx="11">
                  <c:v>3D</c:v>
                </c:pt>
                <c:pt idx="12">
                  <c:v>4A</c:v>
                </c:pt>
                <c:pt idx="13">
                  <c:v>4B</c:v>
                </c:pt>
                <c:pt idx="14">
                  <c:v>4C</c:v>
                </c:pt>
                <c:pt idx="15">
                  <c:v>4D</c:v>
                </c:pt>
                <c:pt idx="16">
                  <c:v>5A</c:v>
                </c:pt>
                <c:pt idx="17">
                  <c:v>5B</c:v>
                </c:pt>
                <c:pt idx="18">
                  <c:v>5C</c:v>
                </c:pt>
                <c:pt idx="19">
                  <c:v>5D</c:v>
                </c:pt>
                <c:pt idx="20">
                  <c:v>6A</c:v>
                </c:pt>
                <c:pt idx="21">
                  <c:v>6B</c:v>
                </c:pt>
                <c:pt idx="22">
                  <c:v>6C</c:v>
                </c:pt>
                <c:pt idx="23">
                  <c:v>6D</c:v>
                </c:pt>
                <c:pt idx="24">
                  <c:v>7A</c:v>
                </c:pt>
                <c:pt idx="25">
                  <c:v>7B</c:v>
                </c:pt>
                <c:pt idx="26">
                  <c:v>7C</c:v>
                </c:pt>
                <c:pt idx="27">
                  <c:v>7D</c:v>
                </c:pt>
              </c:strCache>
            </c:strRef>
          </c:cat>
          <c:val>
            <c:numRef>
              <c:f>Sheet1!$C$2:$C$29</c:f>
              <c:numCache>
                <c:formatCode>General</c:formatCode>
                <c:ptCount val="28"/>
                <c:pt idx="0">
                  <c:v>22531703</c:v>
                </c:pt>
                <c:pt idx="1">
                  <c:v>26139639</c:v>
                </c:pt>
                <c:pt idx="2">
                  <c:v>25588423</c:v>
                </c:pt>
                <c:pt idx="3">
                  <c:v>27297576</c:v>
                </c:pt>
                <c:pt idx="4">
                  <c:v>26862351</c:v>
                </c:pt>
                <c:pt idx="5">
                  <c:v>27483278</c:v>
                </c:pt>
                <c:pt idx="6">
                  <c:v>27140519</c:v>
                </c:pt>
                <c:pt idx="7">
                  <c:v>28417009</c:v>
                </c:pt>
                <c:pt idx="8">
                  <c:v>31023069</c:v>
                </c:pt>
                <c:pt idx="9">
                  <c:v>31218548</c:v>
                </c:pt>
                <c:pt idx="10">
                  <c:v>31575424</c:v>
                </c:pt>
                <c:pt idx="11">
                  <c:v>30950234</c:v>
                </c:pt>
                <c:pt idx="12">
                  <c:v>26546470</c:v>
                </c:pt>
                <c:pt idx="13">
                  <c:v>30781921</c:v>
                </c:pt>
                <c:pt idx="14">
                  <c:v>26806133</c:v>
                </c:pt>
                <c:pt idx="15">
                  <c:v>25468316</c:v>
                </c:pt>
                <c:pt idx="16">
                  <c:v>26180077</c:v>
                </c:pt>
                <c:pt idx="17">
                  <c:v>28334315</c:v>
                </c:pt>
                <c:pt idx="18">
                  <c:v>26828411</c:v>
                </c:pt>
                <c:pt idx="19">
                  <c:v>25736330</c:v>
                </c:pt>
                <c:pt idx="20">
                  <c:v>33700092</c:v>
                </c:pt>
                <c:pt idx="21">
                  <c:v>35862202</c:v>
                </c:pt>
                <c:pt idx="22">
                  <c:v>34853506</c:v>
                </c:pt>
                <c:pt idx="23">
                  <c:v>33281232</c:v>
                </c:pt>
                <c:pt idx="24">
                  <c:v>22875263</c:v>
                </c:pt>
                <c:pt idx="25">
                  <c:v>23978746</c:v>
                </c:pt>
                <c:pt idx="26">
                  <c:v>22525622</c:v>
                </c:pt>
                <c:pt idx="27">
                  <c:v>210161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6DE-4AEF-80A5-DBBE5F280033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FaRR1_hap1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Ref>
              <c:f>Sheet1!$A$2:$A$29</c:f>
              <c:strCache>
                <c:ptCount val="28"/>
                <c:pt idx="0">
                  <c:v>1A</c:v>
                </c:pt>
                <c:pt idx="1">
                  <c:v>1B</c:v>
                </c:pt>
                <c:pt idx="2">
                  <c:v>1C</c:v>
                </c:pt>
                <c:pt idx="3">
                  <c:v>1D</c:v>
                </c:pt>
                <c:pt idx="4">
                  <c:v>2A</c:v>
                </c:pt>
                <c:pt idx="5">
                  <c:v>2B</c:v>
                </c:pt>
                <c:pt idx="6">
                  <c:v>2C</c:v>
                </c:pt>
                <c:pt idx="7">
                  <c:v>2D</c:v>
                </c:pt>
                <c:pt idx="8">
                  <c:v>3A</c:v>
                </c:pt>
                <c:pt idx="9">
                  <c:v>3B</c:v>
                </c:pt>
                <c:pt idx="10">
                  <c:v>3C</c:v>
                </c:pt>
                <c:pt idx="11">
                  <c:v>3D</c:v>
                </c:pt>
                <c:pt idx="12">
                  <c:v>4A</c:v>
                </c:pt>
                <c:pt idx="13">
                  <c:v>4B</c:v>
                </c:pt>
                <c:pt idx="14">
                  <c:v>4C</c:v>
                </c:pt>
                <c:pt idx="15">
                  <c:v>4D</c:v>
                </c:pt>
                <c:pt idx="16">
                  <c:v>5A</c:v>
                </c:pt>
                <c:pt idx="17">
                  <c:v>5B</c:v>
                </c:pt>
                <c:pt idx="18">
                  <c:v>5C</c:v>
                </c:pt>
                <c:pt idx="19">
                  <c:v>5D</c:v>
                </c:pt>
                <c:pt idx="20">
                  <c:v>6A</c:v>
                </c:pt>
                <c:pt idx="21">
                  <c:v>6B</c:v>
                </c:pt>
                <c:pt idx="22">
                  <c:v>6C</c:v>
                </c:pt>
                <c:pt idx="23">
                  <c:v>6D</c:v>
                </c:pt>
                <c:pt idx="24">
                  <c:v>7A</c:v>
                </c:pt>
                <c:pt idx="25">
                  <c:v>7B</c:v>
                </c:pt>
                <c:pt idx="26">
                  <c:v>7C</c:v>
                </c:pt>
                <c:pt idx="27">
                  <c:v>7D</c:v>
                </c:pt>
              </c:strCache>
            </c:strRef>
          </c:cat>
          <c:val>
            <c:numRef>
              <c:f>Sheet1!$D$2:$D$29</c:f>
              <c:numCache>
                <c:formatCode>General</c:formatCode>
                <c:ptCount val="28"/>
                <c:pt idx="0">
                  <c:v>22855991</c:v>
                </c:pt>
                <c:pt idx="1">
                  <c:v>25894854</c:v>
                </c:pt>
                <c:pt idx="2">
                  <c:v>25722849</c:v>
                </c:pt>
                <c:pt idx="3">
                  <c:v>26068445</c:v>
                </c:pt>
                <c:pt idx="4">
                  <c:v>27491849</c:v>
                </c:pt>
                <c:pt idx="5">
                  <c:v>27418049</c:v>
                </c:pt>
                <c:pt idx="6">
                  <c:v>26662861</c:v>
                </c:pt>
                <c:pt idx="7">
                  <c:v>26601834</c:v>
                </c:pt>
                <c:pt idx="8">
                  <c:v>31413151</c:v>
                </c:pt>
                <c:pt idx="9">
                  <c:v>30825160</c:v>
                </c:pt>
                <c:pt idx="10">
                  <c:v>31136822</c:v>
                </c:pt>
                <c:pt idx="11">
                  <c:v>30209456</c:v>
                </c:pt>
                <c:pt idx="12">
                  <c:v>26690241</c:v>
                </c:pt>
                <c:pt idx="13">
                  <c:v>30438350</c:v>
                </c:pt>
                <c:pt idx="14">
                  <c:v>27481372</c:v>
                </c:pt>
                <c:pt idx="15">
                  <c:v>24913570</c:v>
                </c:pt>
                <c:pt idx="16">
                  <c:v>26468837</c:v>
                </c:pt>
                <c:pt idx="17">
                  <c:v>29153715</c:v>
                </c:pt>
                <c:pt idx="18">
                  <c:v>26974999</c:v>
                </c:pt>
                <c:pt idx="19">
                  <c:v>25732751</c:v>
                </c:pt>
                <c:pt idx="20">
                  <c:v>34436226</c:v>
                </c:pt>
                <c:pt idx="21">
                  <c:v>35982586</c:v>
                </c:pt>
                <c:pt idx="22">
                  <c:v>35269636</c:v>
                </c:pt>
                <c:pt idx="23">
                  <c:v>32927424</c:v>
                </c:pt>
                <c:pt idx="24">
                  <c:v>22827111</c:v>
                </c:pt>
                <c:pt idx="25">
                  <c:v>23370891</c:v>
                </c:pt>
                <c:pt idx="26">
                  <c:v>22854303</c:v>
                </c:pt>
                <c:pt idx="27">
                  <c:v>225951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E6DE-4AEF-80A5-DBBE5F280033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FaRR1_hap2</c:v>
                </c:pt>
              </c:strCache>
            </c:strRef>
          </c:tx>
          <c:spPr>
            <a:solidFill>
              <a:srgbClr val="FF33CC"/>
            </a:solidFill>
            <a:ln>
              <a:noFill/>
            </a:ln>
            <a:effectLst/>
          </c:spPr>
          <c:invertIfNegative val="0"/>
          <c:cat>
            <c:strRef>
              <c:f>Sheet1!$A$2:$A$29</c:f>
              <c:strCache>
                <c:ptCount val="28"/>
                <c:pt idx="0">
                  <c:v>1A</c:v>
                </c:pt>
                <c:pt idx="1">
                  <c:v>1B</c:v>
                </c:pt>
                <c:pt idx="2">
                  <c:v>1C</c:v>
                </c:pt>
                <c:pt idx="3">
                  <c:v>1D</c:v>
                </c:pt>
                <c:pt idx="4">
                  <c:v>2A</c:v>
                </c:pt>
                <c:pt idx="5">
                  <c:v>2B</c:v>
                </c:pt>
                <c:pt idx="6">
                  <c:v>2C</c:v>
                </c:pt>
                <c:pt idx="7">
                  <c:v>2D</c:v>
                </c:pt>
                <c:pt idx="8">
                  <c:v>3A</c:v>
                </c:pt>
                <c:pt idx="9">
                  <c:v>3B</c:v>
                </c:pt>
                <c:pt idx="10">
                  <c:v>3C</c:v>
                </c:pt>
                <c:pt idx="11">
                  <c:v>3D</c:v>
                </c:pt>
                <c:pt idx="12">
                  <c:v>4A</c:v>
                </c:pt>
                <c:pt idx="13">
                  <c:v>4B</c:v>
                </c:pt>
                <c:pt idx="14">
                  <c:v>4C</c:v>
                </c:pt>
                <c:pt idx="15">
                  <c:v>4D</c:v>
                </c:pt>
                <c:pt idx="16">
                  <c:v>5A</c:v>
                </c:pt>
                <c:pt idx="17">
                  <c:v>5B</c:v>
                </c:pt>
                <c:pt idx="18">
                  <c:v>5C</c:v>
                </c:pt>
                <c:pt idx="19">
                  <c:v>5D</c:v>
                </c:pt>
                <c:pt idx="20">
                  <c:v>6A</c:v>
                </c:pt>
                <c:pt idx="21">
                  <c:v>6B</c:v>
                </c:pt>
                <c:pt idx="22">
                  <c:v>6C</c:v>
                </c:pt>
                <c:pt idx="23">
                  <c:v>6D</c:v>
                </c:pt>
                <c:pt idx="24">
                  <c:v>7A</c:v>
                </c:pt>
                <c:pt idx="25">
                  <c:v>7B</c:v>
                </c:pt>
                <c:pt idx="26">
                  <c:v>7C</c:v>
                </c:pt>
                <c:pt idx="27">
                  <c:v>7D</c:v>
                </c:pt>
              </c:strCache>
            </c:strRef>
          </c:cat>
          <c:val>
            <c:numRef>
              <c:f>Sheet1!$E$2:$E$29</c:f>
              <c:numCache>
                <c:formatCode>General</c:formatCode>
                <c:ptCount val="28"/>
                <c:pt idx="0">
                  <c:v>22149862</c:v>
                </c:pt>
                <c:pt idx="1">
                  <c:v>25931632</c:v>
                </c:pt>
                <c:pt idx="2">
                  <c:v>25566964</c:v>
                </c:pt>
                <c:pt idx="3">
                  <c:v>26286749</c:v>
                </c:pt>
                <c:pt idx="4">
                  <c:v>27487145</c:v>
                </c:pt>
                <c:pt idx="5">
                  <c:v>27417387</c:v>
                </c:pt>
                <c:pt idx="6">
                  <c:v>27223255</c:v>
                </c:pt>
                <c:pt idx="7">
                  <c:v>28082264</c:v>
                </c:pt>
                <c:pt idx="8">
                  <c:v>31325865</c:v>
                </c:pt>
                <c:pt idx="9">
                  <c:v>31256976</c:v>
                </c:pt>
                <c:pt idx="10">
                  <c:v>31011180</c:v>
                </c:pt>
                <c:pt idx="11">
                  <c:v>30162378</c:v>
                </c:pt>
                <c:pt idx="12">
                  <c:v>26804095</c:v>
                </c:pt>
                <c:pt idx="13">
                  <c:v>30856192</c:v>
                </c:pt>
                <c:pt idx="14">
                  <c:v>26803992</c:v>
                </c:pt>
                <c:pt idx="15">
                  <c:v>24790809</c:v>
                </c:pt>
                <c:pt idx="16">
                  <c:v>26406975</c:v>
                </c:pt>
                <c:pt idx="17">
                  <c:v>28042548</c:v>
                </c:pt>
                <c:pt idx="18">
                  <c:v>27044276</c:v>
                </c:pt>
                <c:pt idx="19">
                  <c:v>26110821</c:v>
                </c:pt>
                <c:pt idx="20">
                  <c:v>34154289</c:v>
                </c:pt>
                <c:pt idx="21">
                  <c:v>35436634</c:v>
                </c:pt>
                <c:pt idx="22">
                  <c:v>34899819</c:v>
                </c:pt>
                <c:pt idx="23">
                  <c:v>33827677</c:v>
                </c:pt>
                <c:pt idx="24">
                  <c:v>22554989</c:v>
                </c:pt>
                <c:pt idx="25">
                  <c:v>23234183</c:v>
                </c:pt>
                <c:pt idx="26">
                  <c:v>22340511</c:v>
                </c:pt>
                <c:pt idx="27">
                  <c:v>2254363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E6DE-4AEF-80A5-DBBE5F280033}"/>
            </c:ext>
          </c:extLst>
        </c:ser>
        <c:ser>
          <c:idx val="4"/>
          <c:order val="4"/>
          <c:tx>
            <c:strRef>
              <c:f>Sheet1!$F$1</c:f>
              <c:strCache>
                <c:ptCount val="1"/>
                <c:pt idx="0">
                  <c:v>Camarosa</c:v>
                </c:pt>
              </c:strCache>
            </c:strRef>
          </c:tx>
          <c:spPr>
            <a:solidFill>
              <a:srgbClr val="002060"/>
            </a:solidFill>
            <a:ln>
              <a:noFill/>
            </a:ln>
            <a:effectLst/>
          </c:spPr>
          <c:invertIfNegative val="0"/>
          <c:cat>
            <c:strRef>
              <c:f>Sheet1!$A$2:$A$29</c:f>
              <c:strCache>
                <c:ptCount val="28"/>
                <c:pt idx="0">
                  <c:v>1A</c:v>
                </c:pt>
                <c:pt idx="1">
                  <c:v>1B</c:v>
                </c:pt>
                <c:pt idx="2">
                  <c:v>1C</c:v>
                </c:pt>
                <c:pt idx="3">
                  <c:v>1D</c:v>
                </c:pt>
                <c:pt idx="4">
                  <c:v>2A</c:v>
                </c:pt>
                <c:pt idx="5">
                  <c:v>2B</c:v>
                </c:pt>
                <c:pt idx="6">
                  <c:v>2C</c:v>
                </c:pt>
                <c:pt idx="7">
                  <c:v>2D</c:v>
                </c:pt>
                <c:pt idx="8">
                  <c:v>3A</c:v>
                </c:pt>
                <c:pt idx="9">
                  <c:v>3B</c:v>
                </c:pt>
                <c:pt idx="10">
                  <c:v>3C</c:v>
                </c:pt>
                <c:pt idx="11">
                  <c:v>3D</c:v>
                </c:pt>
                <c:pt idx="12">
                  <c:v>4A</c:v>
                </c:pt>
                <c:pt idx="13">
                  <c:v>4B</c:v>
                </c:pt>
                <c:pt idx="14">
                  <c:v>4C</c:v>
                </c:pt>
                <c:pt idx="15">
                  <c:v>4D</c:v>
                </c:pt>
                <c:pt idx="16">
                  <c:v>5A</c:v>
                </c:pt>
                <c:pt idx="17">
                  <c:v>5B</c:v>
                </c:pt>
                <c:pt idx="18">
                  <c:v>5C</c:v>
                </c:pt>
                <c:pt idx="19">
                  <c:v>5D</c:v>
                </c:pt>
                <c:pt idx="20">
                  <c:v>6A</c:v>
                </c:pt>
                <c:pt idx="21">
                  <c:v>6B</c:v>
                </c:pt>
                <c:pt idx="22">
                  <c:v>6C</c:v>
                </c:pt>
                <c:pt idx="23">
                  <c:v>6D</c:v>
                </c:pt>
                <c:pt idx="24">
                  <c:v>7A</c:v>
                </c:pt>
                <c:pt idx="25">
                  <c:v>7B</c:v>
                </c:pt>
                <c:pt idx="26">
                  <c:v>7C</c:v>
                </c:pt>
                <c:pt idx="27">
                  <c:v>7D</c:v>
                </c:pt>
              </c:strCache>
            </c:strRef>
          </c:cat>
          <c:val>
            <c:numRef>
              <c:f>Sheet1!$F$2:$F$29</c:f>
              <c:numCache>
                <c:formatCode>General</c:formatCode>
                <c:ptCount val="28"/>
                <c:pt idx="0">
                  <c:v>22887349</c:v>
                </c:pt>
                <c:pt idx="1">
                  <c:v>28910674</c:v>
                </c:pt>
                <c:pt idx="2">
                  <c:v>27436561</c:v>
                </c:pt>
                <c:pt idx="3">
                  <c:v>27594200</c:v>
                </c:pt>
                <c:pt idx="4">
                  <c:v>24782128</c:v>
                </c:pt>
                <c:pt idx="5">
                  <c:v>26692599</c:v>
                </c:pt>
                <c:pt idx="6">
                  <c:v>26582685</c:v>
                </c:pt>
                <c:pt idx="7">
                  <c:v>24073015</c:v>
                </c:pt>
                <c:pt idx="8">
                  <c:v>27809139</c:v>
                </c:pt>
                <c:pt idx="9">
                  <c:v>31459976</c:v>
                </c:pt>
                <c:pt idx="10">
                  <c:v>29626823</c:v>
                </c:pt>
                <c:pt idx="11">
                  <c:v>32005440</c:v>
                </c:pt>
                <c:pt idx="12">
                  <c:v>31955388</c:v>
                </c:pt>
                <c:pt idx="13">
                  <c:v>26295489</c:v>
                </c:pt>
                <c:pt idx="14">
                  <c:v>25974422</c:v>
                </c:pt>
                <c:pt idx="15">
                  <c:v>20034018</c:v>
                </c:pt>
                <c:pt idx="16">
                  <c:v>29826953</c:v>
                </c:pt>
                <c:pt idx="17">
                  <c:v>27452983</c:v>
                </c:pt>
                <c:pt idx="18">
                  <c:v>25211045</c:v>
                </c:pt>
                <c:pt idx="19">
                  <c:v>24981319</c:v>
                </c:pt>
                <c:pt idx="20">
                  <c:v>36657112</c:v>
                </c:pt>
                <c:pt idx="21">
                  <c:v>43627644</c:v>
                </c:pt>
                <c:pt idx="22">
                  <c:v>36124132</c:v>
                </c:pt>
                <c:pt idx="23">
                  <c:v>34274104</c:v>
                </c:pt>
                <c:pt idx="24">
                  <c:v>32354134</c:v>
                </c:pt>
                <c:pt idx="25">
                  <c:v>25137763</c:v>
                </c:pt>
                <c:pt idx="26">
                  <c:v>32186896</c:v>
                </c:pt>
                <c:pt idx="27">
                  <c:v>235347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E6DE-4AEF-80A5-DBBE5F28003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39757456"/>
        <c:axId val="1139759424"/>
      </c:barChart>
      <c:catAx>
        <c:axId val="11397574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39759424"/>
        <c:crosses val="autoZero"/>
        <c:auto val="1"/>
        <c:lblAlgn val="ctr"/>
        <c:lblOffset val="100"/>
        <c:noMultiLvlLbl val="0"/>
      </c:catAx>
      <c:valAx>
        <c:axId val="1139759424"/>
        <c:scaling>
          <c:orientation val="minMax"/>
          <c:max val="40000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39757456"/>
        <c:crosses val="autoZero"/>
        <c:crossBetween val="between"/>
        <c:dispUnits>
          <c:builtInUnit val="millions"/>
          <c:dispUnitsLbl>
            <c:tx>
              <c:rich>
                <a:bodyPr rot="-5400000" spcFirstLastPara="1" vertOverflow="ellipsis" vert="horz" wrap="square" anchor="ctr" anchorCtr="1"/>
                <a:lstStyle/>
                <a:p>
                  <a:pPr>
                    <a:defRPr sz="12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r>
                    <a:rPr lang="en-US"/>
                    <a:t>Mb</a:t>
                  </a:r>
                  <a:endParaRPr lang="ko-KR"/>
                </a:p>
              </c:rich>
            </c:tx>
            <c:spPr>
              <a:noFill/>
              <a:ln>
                <a:noFill/>
              </a:ln>
              <a:effectLst/>
            </c:spPr>
            <c:txPr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</c:dispUnitsLbl>
        </c:dispUnits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FB05960-D7CB-75D3-DCC3-0E1447C8A36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BB132C66-3339-1320-6463-AC400819573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B5FBBBD-A985-FBCF-3B45-C09E66C193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38C67-A60A-4E63-A31F-7CD4389E8AD3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9C51850-06E1-395D-43D1-1A9DB42C92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483716B-A835-F8EC-EEF9-62328226BC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6980C-34B3-4DFB-B295-C8E93C20F2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15914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30D38B8-D961-3B84-9AA8-FEC9DAA70C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01901992-33C0-F24B-A5F1-9C37863A3BF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FFEE0ACE-BF35-95AC-3BF2-8A35CD5743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38C67-A60A-4E63-A31F-7CD4389E8AD3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454F0C6-0C32-29B3-4144-3D1784A390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E66AB5E-CAD7-93ED-1E25-98CF093834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6980C-34B3-4DFB-B295-C8E93C20F2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38259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A0C958CA-705B-A380-06AF-21AC1E063A7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30B144D2-6D96-B905-AF16-784C1F9BFA3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42B38FA2-3191-EB01-90BA-75835664B7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38C67-A60A-4E63-A31F-7CD4389E8AD3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254C95E-1C99-521F-DE8B-5089942C6A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DC1E90C-23EF-F16C-0F74-CBB3DA7DEC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6980C-34B3-4DFB-B295-C8E93C20F2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81325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6B3C785-99D1-BE2F-0501-D8F003E6F1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98A2E0B1-B255-3F8B-7278-F3FB2B775CB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11909FB-2206-A36B-96F7-32C82805BE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38C67-A60A-4E63-A31F-7CD4389E8AD3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3FDC741-74EF-1DF8-B11C-1A6093CAC4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821BDE50-FA05-7E27-0579-1E6357BA2C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6980C-34B3-4DFB-B295-C8E93C20F2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80481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5508222-9537-0CE2-4464-4EABDD6A01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B9AE2187-0B7D-EDDE-0720-4EFFC70FA9C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2E345A6-4F58-BF6B-8E6A-812B29C83F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38C67-A60A-4E63-A31F-7CD4389E8AD3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7E30DFE-9F28-6926-2E33-495B24081A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656B6F1-308C-9B96-7E47-FC41E8ECFB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6980C-34B3-4DFB-B295-C8E93C20F2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99456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C6E51F8-9714-D7EE-EA34-E8166DB5F0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C2CC3C74-FA6C-BA05-097E-2C2D04F9CCB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D85A6C1B-DA76-9938-EF98-885ACBA149D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E3F6E229-8D7D-0CA1-9896-534334FF7C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38C67-A60A-4E63-A31F-7CD4389E8AD3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B33AB812-3E76-C624-F2AD-93865745BF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61CB88F1-DCC5-B81E-D382-1EFF275FA6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6980C-34B3-4DFB-B295-C8E93C20F2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7177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8FF5477-54FC-F362-3E63-87DACD488F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24D24DDE-22AD-20F3-A4D0-53DAD5B0A8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8F89EB4B-699D-5F87-F60B-0DD44CB00EE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9A549626-7A62-42D3-F0ED-5B9F0135EFF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7BB1FE21-135E-A75B-BD18-28DE69733D6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D7C5C22C-3103-529F-655D-8C344DFD1C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38C67-A60A-4E63-A31F-7CD4389E8AD3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F0A81ABE-9A52-F5C2-5E41-8B09625B53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CEEBD3D3-E81B-4E3E-3528-E34659D5E2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6980C-34B3-4DFB-B295-C8E93C20F2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82731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8AAE8D4-BDB0-7358-22C3-B7C961585F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494419DA-5E9C-61CB-3EB6-35A4000D76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38C67-A60A-4E63-A31F-7CD4389E8AD3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0472C15C-DC63-1518-38AC-E1D54DD7A9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E52CBFDC-30FC-3358-0DB6-0912C36873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6980C-34B3-4DFB-B295-C8E93C20F2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5433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C369B2B9-D009-5381-CA57-94B694E50A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38C67-A60A-4E63-A31F-7CD4389E8AD3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43CCC03E-268C-DF85-5EDD-BB682481C7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1C763D93-BEE2-9EF8-C8F5-58EB7DA73A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6980C-34B3-4DFB-B295-C8E93C20F2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43728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3064990-6816-205E-4C3A-3D9FBB7B2C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82135E5F-20AE-1632-DF0F-CBD0643DB11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4E3FF4FA-22DD-3D0F-1D2C-FEC82521785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7380CA1C-9D29-ED08-829D-297DE6514F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38C67-A60A-4E63-A31F-7CD4389E8AD3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228C936A-A626-FD17-08FD-10DA2C42A2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DB176E06-ED6C-1590-B3CA-4656E0B96A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6980C-34B3-4DFB-B295-C8E93C20F2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99546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01DF966-D50B-9B6B-6584-510FCE4DA0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50098052-9D18-0A88-62B5-63ADFDA1DAA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3AC88C14-4924-E967-0941-02E2DED722E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26B9329B-0818-D85A-0B8D-72056846F3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38C67-A60A-4E63-A31F-7CD4389E8AD3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4730CE88-A513-384B-7A58-972274B636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03396F9A-E99A-9383-F142-338373200D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6980C-34B3-4DFB-B295-C8E93C20F2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75889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ADABB5C3-6F6D-381F-1EEF-4FF8DF4A3F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AA4086C8-0B30-AB92-34FD-4586CB8053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46A5BA5-7FCB-448E-9881-636B359E4CD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A38C67-A60A-4E63-A31F-7CD4389E8AD3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1F4025C-E2EF-B151-6EB9-63137A15827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4873D14-4E8E-9936-89A5-7667D88AE73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36980C-34B3-4DFB-B295-C8E93C20F2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20082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차트 6">
            <a:extLst>
              <a:ext uri="{FF2B5EF4-FFF2-40B4-BE49-F238E27FC236}">
                <a16:creationId xmlns:a16="http://schemas.microsoft.com/office/drawing/2014/main" id="{333E5BB1-1CEA-3E44-167A-BD84BC4F962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8017993"/>
              </p:ext>
            </p:extLst>
          </p:nvPr>
        </p:nvGraphicFramePr>
        <p:xfrm>
          <a:off x="203200" y="606025"/>
          <a:ext cx="11146972" cy="47126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9595387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0</Words>
  <Application>Microsoft Office PowerPoint</Application>
  <PresentationFormat>와이드스크린</PresentationFormat>
  <Paragraphs>0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테마</vt:lpstr>
      <vt:lpstr>PowerPoint 프레젠테이션</vt:lpstr>
    </vt:vector>
  </TitlesOfParts>
  <Company>University of Florid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Han, Hyeondae</dc:creator>
  <cp:lastModifiedBy>Han, Hyeondae</cp:lastModifiedBy>
  <cp:revision>8</cp:revision>
  <dcterms:created xsi:type="dcterms:W3CDTF">2024-03-17T20:37:52Z</dcterms:created>
  <dcterms:modified xsi:type="dcterms:W3CDTF">2024-08-09T02:37:41Z</dcterms:modified>
</cp:coreProperties>
</file>